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492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輸血細胞治療部 鹿児島大学病院" initials="輸血細胞治療部" lastIdx="1" clrIdx="0">
    <p:extLst>
      <p:ext uri="{19B8F6BF-5375-455C-9EA6-DF929625EA0E}">
        <p15:presenceInfo xmlns:p15="http://schemas.microsoft.com/office/powerpoint/2012/main" userId="02bc7de5e83b26e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96" autoAdjust="0"/>
    <p:restoredTop sz="94694"/>
  </p:normalViewPr>
  <p:slideViewPr>
    <p:cSldViewPr snapToGrid="0">
      <p:cViewPr varScale="1">
        <p:scale>
          <a:sx n="115" d="100"/>
          <a:sy n="115" d="100"/>
        </p:scale>
        <p:origin x="216" y="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A1156C-EE16-70C4-D6BF-4354E31DE3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A08F850-1F20-9CD3-F7C8-02732DD0B2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16DAD1-E159-503E-144F-A0284128C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90F4D6-3368-E66D-73E5-C71481512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3FFFB84-DF9B-66BF-B815-8AA742502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276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8EFE4F-BF80-0FB6-B794-3ACCDD4B9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2B59B40-89AD-64E1-6901-3A222B9039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935B18-2F73-B774-D8AE-E0EF50B42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ADEA6F-C47D-1957-8135-51CB6FC88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9EC8F6-7F1C-49DE-5CBB-C6D01CC9F2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7251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D70444B-B57F-7C8D-3A7C-85B59C016E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CDC6ED0-1F18-7F90-2150-DFCC5100B2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6BC3F3-C057-6DEC-41D9-26CA433BF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368F69-A41D-7EA7-C84A-7E18E5453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4ACC6A7-B10D-73F4-71DA-A33482BB6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043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12DAED-418D-C9FF-134A-FB56C4E5A0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D206C0-F013-E256-08C4-918D4E202E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0FA46B-B276-2C68-2CC3-329303809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B8F15E4-7BAB-6702-C982-614CE740F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E6F656-C641-0CB7-4DEC-B3299BACA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2390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7444D2-3ED4-EB92-8138-879EA8A0D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68BE15-A4C3-3A11-BD89-F53A418A12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DEBE9D-220C-C725-D15F-52356E23F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7B9EF65-5EFA-4D36-65DF-4A16BE5DE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D60E57-60F1-C9EC-96DD-8119EED88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7102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B21212-08A6-9C27-BCDB-6B5EBCF2CC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4B20D7-8D54-7D63-DFB4-D5DF7BEDB1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D4E2687-2C79-51E6-DB61-0EC4C91AC8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383A750-E540-8221-6FC3-B98444E68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3EE91CF-9E49-0ECF-E87C-7B6E904E7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12A4E9-CC5A-C384-BC54-EF9E6FE48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4787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626826-5899-47F8-3401-2DB0585179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161750B-DDB8-B217-BE1B-917E69DA10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5CD4064-F0EA-02D6-7338-FF5E5C42C3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EA4C39A-6D91-C236-A343-2B20D6E3FB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CE25A90-C12D-2F3E-DD67-F091F77025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18E3228-5884-8EC6-A782-67128EC76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3EA8800-F6D6-2E7F-28E7-A39DDD9A1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8285D60-DED0-4588-1B19-C20B7D4CF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3269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A5115D-3DAD-5E3B-F23D-F4FE925EE4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B633A7A-862B-6E47-AEB4-1CF4D1F33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A3E3948-71B5-DA0D-4CE4-84860D65F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BCADB6F-BF63-AFFB-E63A-74D6A80F3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1031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EDC9E62-6DAB-F009-C043-7234D6468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3005D02-01A4-AF93-32DF-335FA7D18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8E13CDE-E91E-56D7-792F-8AB6C1662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1619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FED836-21AA-EBBD-11D4-1F521599E4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8F192E1-9867-5C76-1911-36A5BF7B51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BE7CC40-6DB8-18B0-2392-4BBD8235D1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5ACF6B0-2A51-E234-210D-080A9F7D5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C338FF2-E44A-6459-D627-EBBCC9454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BB0AEA8-DD3E-9AB2-BEB4-B3597D78D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3972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32CB43-6366-C88F-B084-7FCCF2E86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67DEE30-E04B-3418-EF43-842AFE8369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C21F117-5FDC-3971-058B-402E00D111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ED8403A-8D97-04FC-40DA-A266F6B08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D3843B6-3981-D4C7-B447-D82734D75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23CE771-D5AF-4826-6CE1-1E14EE916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109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6A43818-C206-92C0-6BD7-C8AD1E7CC7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999898F-40EF-09B4-1575-B378A720DD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F50CD2-B267-8AC9-687C-BAA198C66B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0A2D12-77A2-1B40-AE77-47F814DBB208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E12A90-9350-0FA5-9CB4-585EAC1A3F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3782D0-A8EB-B6B6-34B4-A7E401D316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1B8FE8-569A-9546-8968-753B565D1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592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57BCF06-20A1-BB54-7593-18177ABC84F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470C7AEC-0F52-58E9-9D9C-DE5AB18D8E2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246" t="8579" r="9927" b="5480"/>
          <a:stretch>
            <a:fillRect/>
          </a:stretch>
        </p:blipFill>
        <p:spPr>
          <a:xfrm>
            <a:off x="4251038" y="828334"/>
            <a:ext cx="3583673" cy="5104791"/>
          </a:xfrm>
          <a:prstGeom prst="rect">
            <a:avLst/>
          </a:prstGeom>
          <a:ln w="15875">
            <a:noFill/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6EB2EB1-4BD8-4C43-97BC-8F58566F971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812" t="3826" r="8703" b="5621"/>
          <a:stretch>
            <a:fillRect/>
          </a:stretch>
        </p:blipFill>
        <p:spPr>
          <a:xfrm>
            <a:off x="430401" y="554404"/>
            <a:ext cx="3583673" cy="5213619"/>
          </a:xfrm>
          <a:prstGeom prst="rect">
            <a:avLst/>
          </a:prstGeom>
          <a:noFill/>
          <a:ln w="15875">
            <a:noFill/>
          </a:ln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3CC96F2-683E-8589-A63F-AB45A9460EC3}"/>
              </a:ext>
            </a:extLst>
          </p:cNvPr>
          <p:cNvSpPr txBox="1"/>
          <p:nvPr/>
        </p:nvSpPr>
        <p:spPr>
          <a:xfrm>
            <a:off x="430401" y="5947756"/>
            <a:ext cx="48734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+mn-ea"/>
                <a:cs typeface="Arial" panose="020B0604020202020204" pitchFamily="34" charset="0"/>
              </a:rPr>
              <a:t>Additional file 1</a:t>
            </a:r>
          </a:p>
          <a:p>
            <a:r>
              <a:rPr lang="en-US" altLang="ja-JP" dirty="0">
                <a:latin typeface="+mn-ea"/>
                <a:cs typeface="Arial" panose="020B0604020202020204" pitchFamily="34" charset="0"/>
              </a:rPr>
              <a:t>HIF-1α and HIF-2α (left), β-actin (right)</a:t>
            </a:r>
            <a:endParaRPr kumimoji="1" lang="ja-JP" altLang="en-US" dirty="0">
              <a:latin typeface="+mn-ea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9269C49-3EFF-8D06-94C1-FA7BA07D30B7}"/>
              </a:ext>
            </a:extLst>
          </p:cNvPr>
          <p:cNvSpPr txBox="1"/>
          <p:nvPr/>
        </p:nvSpPr>
        <p:spPr>
          <a:xfrm>
            <a:off x="1333692" y="176506"/>
            <a:ext cx="19223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+mn-ea"/>
                <a:cs typeface="Arial" panose="020B0604020202020204" pitchFamily="34" charset="0"/>
              </a:rPr>
              <a:t>Long exposure</a:t>
            </a:r>
            <a:endParaRPr kumimoji="1" lang="en-US" altLang="ja-JP" sz="2000" dirty="0">
              <a:latin typeface="+mn-ea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400E3E4-AED7-F6A3-42A5-28CA96431D5C}"/>
              </a:ext>
            </a:extLst>
          </p:cNvPr>
          <p:cNvSpPr txBox="1"/>
          <p:nvPr/>
        </p:nvSpPr>
        <p:spPr>
          <a:xfrm>
            <a:off x="5134839" y="176506"/>
            <a:ext cx="19704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+mn-ea"/>
                <a:cs typeface="Arial" panose="020B0604020202020204" pitchFamily="34" charset="0"/>
              </a:rPr>
              <a:t>Short exposure</a:t>
            </a:r>
            <a:endParaRPr kumimoji="1" lang="en-US" altLang="ja-JP" sz="2000" dirty="0">
              <a:latin typeface="+mn-ea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770814CE-8A94-8CAC-BB58-8D6327C1E7F1}"/>
              </a:ext>
            </a:extLst>
          </p:cNvPr>
          <p:cNvSpPr/>
          <p:nvPr/>
        </p:nvSpPr>
        <p:spPr>
          <a:xfrm>
            <a:off x="958862" y="1420978"/>
            <a:ext cx="2408806" cy="503537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DC58F06-B522-B990-B001-AA094715C916}"/>
              </a:ext>
            </a:extLst>
          </p:cNvPr>
          <p:cNvSpPr txBox="1"/>
          <p:nvPr/>
        </p:nvSpPr>
        <p:spPr>
          <a:xfrm>
            <a:off x="958860" y="1002579"/>
            <a:ext cx="9749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F-1α</a:t>
            </a:r>
            <a:endParaRPr kumimoji="1" lang="en-US" altLang="ja-JP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23547613-238B-FBC7-6EED-CB1CA7C9CF49}"/>
              </a:ext>
            </a:extLst>
          </p:cNvPr>
          <p:cNvSpPr/>
          <p:nvPr/>
        </p:nvSpPr>
        <p:spPr>
          <a:xfrm>
            <a:off x="958860" y="2575125"/>
            <a:ext cx="2408808" cy="40011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DD54A94-A533-554F-1E5B-175B2B1D1F59}"/>
              </a:ext>
            </a:extLst>
          </p:cNvPr>
          <p:cNvSpPr txBox="1"/>
          <p:nvPr/>
        </p:nvSpPr>
        <p:spPr>
          <a:xfrm>
            <a:off x="958860" y="2175015"/>
            <a:ext cx="9749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F-2α</a:t>
            </a:r>
            <a:endParaRPr kumimoji="1" lang="en-US" altLang="ja-JP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15A1794B-6791-F491-DB36-0FFF14ECEDE7}"/>
              </a:ext>
            </a:extLst>
          </p:cNvPr>
          <p:cNvSpPr/>
          <p:nvPr/>
        </p:nvSpPr>
        <p:spPr>
          <a:xfrm>
            <a:off x="4728117" y="3773891"/>
            <a:ext cx="2542478" cy="46620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87FADEC-7213-14CF-155D-7C50D6F83648}"/>
              </a:ext>
            </a:extLst>
          </p:cNvPr>
          <p:cNvSpPr txBox="1"/>
          <p:nvPr/>
        </p:nvSpPr>
        <p:spPr>
          <a:xfrm>
            <a:off x="4662299" y="3359150"/>
            <a:ext cx="9589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en-US" altLang="ja-JP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85533B6F-8B96-9B38-074E-275FA94118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77928" y="708527"/>
            <a:ext cx="3860130" cy="53012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8612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4</TotalTime>
  <Words>20</Words>
  <Application>Microsoft Macintosh PowerPoint</Application>
  <PresentationFormat>ワイド画面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寛仁 橋ノ口</dc:creator>
  <cp:lastModifiedBy>寛仁 橋ノ口</cp:lastModifiedBy>
  <cp:revision>14</cp:revision>
  <cp:lastPrinted>2025-12-26T01:50:36Z</cp:lastPrinted>
  <dcterms:created xsi:type="dcterms:W3CDTF">2024-11-24T12:46:38Z</dcterms:created>
  <dcterms:modified xsi:type="dcterms:W3CDTF">2026-03-22T14:27:34Z</dcterms:modified>
</cp:coreProperties>
</file>